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83" r:id="rId2"/>
    <p:sldId id="259" r:id="rId3"/>
    <p:sldId id="257" r:id="rId4"/>
    <p:sldId id="258" r:id="rId5"/>
    <p:sldId id="274" r:id="rId6"/>
    <p:sldId id="301" r:id="rId7"/>
    <p:sldId id="299" r:id="rId8"/>
    <p:sldId id="302" r:id="rId9"/>
    <p:sldId id="300" r:id="rId10"/>
    <p:sldId id="303" r:id="rId11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wler Jr, John" initials="FJJ" lastIdx="1" clrIdx="0"/>
  <p:cmAuthor id="2" name="USER" initials="U" lastIdx="3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72C4"/>
    <a:srgbClr val="F907D6"/>
    <a:srgbClr val="E6E6E6"/>
    <a:srgbClr val="FF0000"/>
    <a:srgbClr val="C6D9F1"/>
    <a:srgbClr val="D6D6D6"/>
    <a:srgbClr val="636363"/>
    <a:srgbClr val="5C5C5C"/>
    <a:srgbClr val="44AA99"/>
    <a:srgbClr val="C050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234" autoAdjust="0"/>
    <p:restoredTop sz="86330"/>
  </p:normalViewPr>
  <p:slideViewPr>
    <p:cSldViewPr snapToGrid="0">
      <p:cViewPr varScale="1">
        <p:scale>
          <a:sx n="82" d="100"/>
          <a:sy n="82" d="100"/>
        </p:scale>
        <p:origin x="396" y="9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8F3E22-F63A-334E-80FB-A0888A7A680B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08960F-57C9-A04E-84E7-391DA69AA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1845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08960F-57C9-A04E-84E7-391DA69AA08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7134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08960F-57C9-A04E-84E7-391DA69AA08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8115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08960F-57C9-A04E-84E7-391DA69AA08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91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08960F-57C9-A04E-84E7-391DA69AA08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0160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4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89FB2E1-7807-4BFF-A8AE-E7D9DFC83FAD}"/>
              </a:ext>
            </a:extLst>
          </p:cNvPr>
          <p:cNvSpPr txBox="1"/>
          <p:nvPr/>
        </p:nvSpPr>
        <p:spPr>
          <a:xfrm>
            <a:off x="368808" y="6263116"/>
            <a:ext cx="612038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. S1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ene structure and motif analysis of LARPs in maize.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ene structure of </a:t>
            </a:r>
            <a:r>
              <a:rPr lang="en-US" altLang="zh-CN" sz="12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ZmLARP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s in maize. Blue boxes represent exons, black lines represent introns, and gray boxes represent untranslated regions.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Motif composition of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ZmLARP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oteins in maize. Colored boxes represent conserved motifs detected in this study.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CE848A48-1052-4E0B-B51F-B0F37B45E69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08" y="1544573"/>
            <a:ext cx="6120384" cy="42260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66260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:a16="http://schemas.microsoft.com/office/drawing/2014/main" id="{E986745B-7E68-4F55-9546-4741BB759727}"/>
              </a:ext>
            </a:extLst>
          </p:cNvPr>
          <p:cNvSpPr txBox="1"/>
          <p:nvPr/>
        </p:nvSpPr>
        <p:spPr>
          <a:xfrm>
            <a:off x="316767" y="6083861"/>
            <a:ext cx="622446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. S10.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Expression analysis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ZmLARP6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genes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n maize pollen evaluated by </a:t>
            </a:r>
            <a:r>
              <a:rPr lang="en-US" altLang="zh-C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qRT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-PCR. Data are means ± SE (</a:t>
            </a:r>
            <a:r>
              <a:rPr lang="en-US" altLang="zh-CN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= 3).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 </a:t>
            </a:r>
            <a:endParaRPr lang="zh-CN" altLang="zh-CN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42E69D1-6E0C-41F0-BEF3-1E4D44A1625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232" y="1883195"/>
            <a:ext cx="5399532" cy="38770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1885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A00452EC-EB78-46C2-80CA-437FC9286AAA}"/>
              </a:ext>
            </a:extLst>
          </p:cNvPr>
          <p:cNvSpPr txBox="1"/>
          <p:nvPr/>
        </p:nvSpPr>
        <p:spPr>
          <a:xfrm>
            <a:off x="449491" y="8126093"/>
            <a:ext cx="595901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</a:t>
            </a:r>
            <a:r>
              <a:rPr lang="en-US" altLang="zh-CN" sz="1200" b="1" dirty="0">
                <a:latin typeface="Times New Roman" panose="02020603050405020304" pitchFamily="18" charset="0"/>
                <a:ea typeface="等线" panose="02010600030101010101" pitchFamily="2" charset="-122"/>
              </a:rPr>
              <a:t>.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S2.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Alignment of amino acid sequences of ZmLARP1 proteins. Red shading, LAM.</a:t>
            </a:r>
            <a:endParaRPr lang="zh-CN" altLang="en-US" sz="1200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E242088-5744-4662-8483-ECA545EBB93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06" y="921258"/>
            <a:ext cx="6120384" cy="6653784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>
            <a:extLst>
              <a:ext uri="{FF2B5EF4-FFF2-40B4-BE49-F238E27FC236}">
                <a16:creationId xmlns:a16="http://schemas.microsoft.com/office/drawing/2014/main" id="{FD49008C-F519-4D8E-9717-8F35AB8C4F12}"/>
              </a:ext>
            </a:extLst>
          </p:cNvPr>
          <p:cNvSpPr txBox="1"/>
          <p:nvPr/>
        </p:nvSpPr>
        <p:spPr>
          <a:xfrm>
            <a:off x="593922" y="6152157"/>
            <a:ext cx="566012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. S3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lignment of amino acid sequences of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ZmL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oteins. Red shading, LAM; blue shading, RRM1; green shading, RRM2.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69C435B-E32F-4FCD-BF99-DE41C63F172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790" y="1606042"/>
            <a:ext cx="6120384" cy="3861816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02CCE840-D74A-4A9D-90C9-CD73F171FA7D}"/>
              </a:ext>
            </a:extLst>
          </p:cNvPr>
          <p:cNvSpPr txBox="1"/>
          <p:nvPr/>
        </p:nvSpPr>
        <p:spPr>
          <a:xfrm>
            <a:off x="368808" y="8399362"/>
            <a:ext cx="612038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. S4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lignment of amino acid sequences ZmLARP6 proteins. Red shading, LAM; purple shading, RRM-L3a; yellow shading, LSA; pink shading, PAM2.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94CE413-453F-4C0F-8CC3-BD5BE09BB2A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08" y="769874"/>
            <a:ext cx="6120384" cy="7350252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A38D47-6FA5-42AD-BAFE-4E3E308130CB}"/>
              </a:ext>
            </a:extLst>
          </p:cNvPr>
          <p:cNvSpPr txBox="1"/>
          <p:nvPr/>
        </p:nvSpPr>
        <p:spPr>
          <a:xfrm>
            <a:off x="347133" y="7912837"/>
            <a:ext cx="616373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. S5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dentification of potential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i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acting elements in the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ZmLARP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omoters in maize.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Different types of 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i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-acting elements are marked by differently colored rectangles. One the left is a phylogenetic tree for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ZmLARP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proteins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Heatmap of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i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acting elements in the promoter of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ZmLARP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oteins. 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9E388F3F-2C01-4066-BF3E-5F316BF2B33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482" y="798516"/>
            <a:ext cx="6120384" cy="67497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01348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>
            <a:extLst>
              <a:ext uri="{FF2B5EF4-FFF2-40B4-BE49-F238E27FC236}">
                <a16:creationId xmlns:a16="http://schemas.microsoft.com/office/drawing/2014/main" id="{5179AC0A-F040-409D-9FA5-E552821F743B}"/>
              </a:ext>
            </a:extLst>
          </p:cNvPr>
          <p:cNvSpPr txBox="1"/>
          <p:nvPr/>
        </p:nvSpPr>
        <p:spPr>
          <a:xfrm>
            <a:off x="597529" y="6066706"/>
            <a:ext cx="5751159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. S6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vitro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ollen germination and pollen tube length.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Germinated, non-germinated, and ruptured pollen grains of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Zmlarp6c1::D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mpared with the wild type (WT) at 15 and 30 min after plating on pollen growth medium (PGM). Data are the mean ± SE (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= 4).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fields-of-view of germinated pollen grains at 30 min after plating on PGM.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Pollen tube length of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Zmlarp6c1::D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the WT at 30 min after plating on PGM. Data are the mean ± SD. *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5, </a:t>
            </a:r>
            <a:r>
              <a:rPr lang="en-US" altLang="zh-CN" sz="12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** </a:t>
            </a:r>
            <a:r>
              <a:rPr lang="en-US" altLang="zh-CN" sz="1200" i="1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1, *** </a:t>
            </a:r>
            <a:r>
              <a:rPr lang="en-US" altLang="zh-CN" sz="1200" i="1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01.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114066E-0ECB-4EA0-8B0A-5F62A0FC9FF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166" y="1532128"/>
            <a:ext cx="5039868" cy="3666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75793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1EBECC60-3378-4B1A-9CB8-BB1FDB1FDD74}"/>
              </a:ext>
            </a:extLst>
          </p:cNvPr>
          <p:cNvSpPr txBox="1"/>
          <p:nvPr/>
        </p:nvSpPr>
        <p:spPr>
          <a:xfrm>
            <a:off x="570089" y="5339982"/>
            <a:ext cx="571782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. S7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ollen grain diameter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ZmLARP6c1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OE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 the wild type (WT). At least 150 pollen grains were measured per replicate. All data are the means of four biological replicates and error bars indicate the SD.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E644EA2-B349-4252-AB05-56F6334A6F7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8316" y="2010664"/>
            <a:ext cx="1801368" cy="2862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42806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385BEF23-E8AD-4EFD-853C-9A04BE2114A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000" y="2143378"/>
            <a:ext cx="5040000" cy="3108468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E4B6FB4E-3F54-49A9-9E67-FCBBD6111175}"/>
              </a:ext>
            </a:extLst>
          </p:cNvPr>
          <p:cNvSpPr txBox="1"/>
          <p:nvPr/>
        </p:nvSpPr>
        <p:spPr>
          <a:xfrm>
            <a:off x="523373" y="5480446"/>
            <a:ext cx="581125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. S8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Classification of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of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DEGs in pollen of 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Zmlarp6c1::D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and 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ZmLARP6c1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-OE compared with WT by using Gene Ontology (GO) functional annotation from Venn diagrams. 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q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value &lt; 0.05.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2318104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:a16="http://schemas.microsoft.com/office/drawing/2014/main" id="{E986745B-7E68-4F55-9546-4741BB759727}"/>
              </a:ext>
            </a:extLst>
          </p:cNvPr>
          <p:cNvSpPr txBox="1"/>
          <p:nvPr/>
        </p:nvSpPr>
        <p:spPr>
          <a:xfrm>
            <a:off x="316768" y="7474177"/>
            <a:ext cx="622446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. S9.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Expression analysis of </a:t>
            </a:r>
            <a:r>
              <a:rPr lang="en-US" altLang="zh-C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jasmonic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acid and abscisic acid biosynthetic, metabolic, mediated signaling pathway, and responsive genes in maize pollen evaluated by </a:t>
            </a:r>
            <a:r>
              <a:rPr lang="en-US" altLang="zh-C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qRT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-PCR. Data are means ± SE (</a:t>
            </a:r>
            <a:r>
              <a:rPr lang="en-US" altLang="zh-CN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= 3). </a:t>
            </a:r>
            <a:endParaRPr lang="zh-CN" altLang="zh-CN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4A97633-45E2-4961-9020-C02F6542CE1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07" y="1183894"/>
            <a:ext cx="6120384" cy="59253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5060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93</TotalTime>
  <Words>476</Words>
  <Application>Microsoft Office PowerPoint</Application>
  <PresentationFormat>全屏显示(4:3)</PresentationFormat>
  <Paragraphs>14</Paragraphs>
  <Slides>10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kht</dc:creator>
  <cp:lastModifiedBy>ZHOU LIAN</cp:lastModifiedBy>
  <cp:revision>421</cp:revision>
  <dcterms:created xsi:type="dcterms:W3CDTF">2019-10-05T08:21:31Z</dcterms:created>
  <dcterms:modified xsi:type="dcterms:W3CDTF">2024-03-03T08:04:57Z</dcterms:modified>
</cp:coreProperties>
</file>